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91" r:id="rId2"/>
    <p:sldId id="293" r:id="rId3"/>
    <p:sldId id="299" r:id="rId4"/>
    <p:sldId id="275" r:id="rId5"/>
    <p:sldId id="277" r:id="rId6"/>
    <p:sldId id="300" r:id="rId7"/>
    <p:sldId id="301" r:id="rId8"/>
  </p:sldIdLst>
  <p:sldSz cx="12192000" cy="6858000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ancesca Motta" initials="FM" lastIdx="17" clrIdx="0">
    <p:extLst>
      <p:ext uri="{19B8F6BF-5375-455C-9EA6-DF929625EA0E}">
        <p15:presenceInfo xmlns:p15="http://schemas.microsoft.com/office/powerpoint/2012/main" userId="Francesca Motta" providerId="None"/>
      </p:ext>
    </p:extLst>
  </p:cmAuthor>
  <p:cmAuthor id="2" name="Francesca Motta" initials="FM [2]" lastIdx="4" clrIdx="1">
    <p:extLst>
      <p:ext uri="{19B8F6BF-5375-455C-9EA6-DF929625EA0E}">
        <p15:presenceInfo xmlns:p15="http://schemas.microsoft.com/office/powerpoint/2012/main" userId="S-1-5-21-3366766030-4177022296-3432442078-1333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DADB"/>
    <a:srgbClr val="C8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0ACDE8-4F99-4CC8-A870-E916FC26D503}" v="5" dt="2023-07-13T11:40:22.66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35" autoAdjust="0"/>
  </p:normalViewPr>
  <p:slideViewPr>
    <p:cSldViewPr snapToGrid="0">
      <p:cViewPr varScale="1">
        <p:scale>
          <a:sx n="84" d="100"/>
          <a:sy n="84" d="100"/>
        </p:scale>
        <p:origin x="1596" y="5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C503A1-57D5-46FB-AE63-E1161AA4F390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C9A695-A36E-4A36-8EF6-035C3BEC990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8686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C9A695-A36E-4A36-8EF6-035C3BEC990F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87071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C9A695-A36E-4A36-8EF6-035C3BEC990F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194373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C9A695-A36E-4A36-8EF6-035C3BEC990F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967867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C9A695-A36E-4A36-8EF6-035C3BEC990F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30500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C9A695-A36E-4A36-8EF6-035C3BEC990F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26807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5012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255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7502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1215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6797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0469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7529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5420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8429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7389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1228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1EDCED-83DF-4CE0-9613-A01F5A1F831D}" type="datetimeFigureOut">
              <a:rPr lang="it-IT" smtClean="0"/>
              <a:t>20/07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684FB9-8FC3-4E51-8C49-5FC47A0FCA7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1718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po 21"/>
          <p:cNvGrpSpPr/>
          <p:nvPr/>
        </p:nvGrpSpPr>
        <p:grpSpPr>
          <a:xfrm>
            <a:off x="2868441" y="522196"/>
            <a:ext cx="5733874" cy="4986339"/>
            <a:chOff x="2868441" y="522196"/>
            <a:chExt cx="5733874" cy="4986339"/>
          </a:xfrm>
        </p:grpSpPr>
        <p:grpSp>
          <p:nvGrpSpPr>
            <p:cNvPr id="23" name="Gruppo 22">
              <a:extLst>
                <a:ext uri="{FF2B5EF4-FFF2-40B4-BE49-F238E27FC236}">
                  <a16:creationId xmlns:a16="http://schemas.microsoft.com/office/drawing/2014/main" id="{B7DBE8F4-EEF4-45F9-9C89-5D3AA287AA99}"/>
                </a:ext>
              </a:extLst>
            </p:cNvPr>
            <p:cNvGrpSpPr/>
            <p:nvPr/>
          </p:nvGrpSpPr>
          <p:grpSpPr>
            <a:xfrm>
              <a:off x="2868441" y="522196"/>
              <a:ext cx="5733874" cy="4986339"/>
              <a:chOff x="2895074" y="531074"/>
              <a:chExt cx="5733874" cy="4986339"/>
            </a:xfrm>
          </p:grpSpPr>
          <p:grpSp>
            <p:nvGrpSpPr>
              <p:cNvPr id="20" name="Gruppo 19">
                <a:extLst>
                  <a:ext uri="{FF2B5EF4-FFF2-40B4-BE49-F238E27FC236}">
                    <a16:creationId xmlns:a16="http://schemas.microsoft.com/office/drawing/2014/main" id="{6F910D51-CF7C-45E2-823A-4A473900E45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895074" y="531074"/>
                <a:ext cx="5733874" cy="4986339"/>
                <a:chOff x="1652517" y="1241381"/>
                <a:chExt cx="5733874" cy="4964589"/>
              </a:xfrm>
            </p:grpSpPr>
            <p:pic>
              <p:nvPicPr>
                <p:cNvPr id="5" name="Immagine 4">
                  <a:extLst>
                    <a:ext uri="{FF2B5EF4-FFF2-40B4-BE49-F238E27FC236}">
                      <a16:creationId xmlns:a16="http://schemas.microsoft.com/office/drawing/2014/main" id="{572E4953-7366-4AF3-ACD5-ED475136F1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304" t="27102" r="61439" b="40362"/>
                <a:stretch/>
              </p:blipFill>
              <p:spPr>
                <a:xfrm>
                  <a:off x="2911366" y="3275641"/>
                  <a:ext cx="2201821" cy="1971363"/>
                </a:xfrm>
                <a:prstGeom prst="rect">
                  <a:avLst/>
                </a:prstGeom>
                <a:ln>
                  <a:solidFill>
                    <a:schemeClr val="accent3">
                      <a:lumMod val="75000"/>
                    </a:schemeClr>
                  </a:solidFill>
                </a:ln>
              </p:spPr>
            </p:pic>
            <p:pic>
              <p:nvPicPr>
                <p:cNvPr id="6" name="Immagine 5">
                  <a:extLst>
                    <a:ext uri="{FF2B5EF4-FFF2-40B4-BE49-F238E27FC236}">
                      <a16:creationId xmlns:a16="http://schemas.microsoft.com/office/drawing/2014/main" id="{4D3B97AE-2320-4676-B9F3-C2BFF6E80D0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1231" t="26959" r="11512" b="40503"/>
                <a:stretch/>
              </p:blipFill>
              <p:spPr>
                <a:xfrm>
                  <a:off x="5184570" y="3275641"/>
                  <a:ext cx="2201821" cy="1971363"/>
                </a:xfrm>
                <a:prstGeom prst="rect">
                  <a:avLst/>
                </a:prstGeom>
                <a:ln>
                  <a:solidFill>
                    <a:schemeClr val="accent3">
                      <a:lumMod val="75000"/>
                    </a:schemeClr>
                  </a:solidFill>
                </a:ln>
              </p:spPr>
            </p:pic>
            <p:cxnSp>
              <p:nvCxnSpPr>
                <p:cNvPr id="7" name="Connettore diritto 6">
                  <a:extLst>
                    <a:ext uri="{FF2B5EF4-FFF2-40B4-BE49-F238E27FC236}">
                      <a16:creationId xmlns:a16="http://schemas.microsoft.com/office/drawing/2014/main" id="{FE3D67D9-C80E-45C6-AE2A-815B442969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6096000" y="5609622"/>
                  <a:ext cx="0" cy="596348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" name="CasellaDiTesto 7">
                  <a:extLst>
                    <a:ext uri="{FF2B5EF4-FFF2-40B4-BE49-F238E27FC236}">
                      <a16:creationId xmlns:a16="http://schemas.microsoft.com/office/drawing/2014/main" id="{32F04451-1E1F-4469-B241-87818398C415}"/>
                    </a:ext>
                  </a:extLst>
                </p:cNvPr>
                <p:cNvSpPr txBox="1"/>
                <p:nvPr/>
              </p:nvSpPr>
              <p:spPr>
                <a:xfrm>
                  <a:off x="6096000" y="5823290"/>
                  <a:ext cx="72327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dirty="0">
                      <a:solidFill>
                        <a:schemeClr val="bg1"/>
                      </a:solidFill>
                    </a:rPr>
                    <a:t>2 mm</a:t>
                  </a:r>
                  <a:endParaRPr lang="en-US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2" name="CasellaDiTesto 1">
                  <a:extLst>
                    <a:ext uri="{FF2B5EF4-FFF2-40B4-BE49-F238E27FC236}">
                      <a16:creationId xmlns:a16="http://schemas.microsoft.com/office/drawing/2014/main" id="{A76D9ECF-EDD0-4E5A-A481-995F2102BBE1}"/>
                    </a:ext>
                  </a:extLst>
                </p:cNvPr>
                <p:cNvSpPr txBox="1"/>
                <p:nvPr/>
              </p:nvSpPr>
              <p:spPr>
                <a:xfrm>
                  <a:off x="3364432" y="5286858"/>
                  <a:ext cx="1353421" cy="3370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IASTOLE</a:t>
                  </a:r>
                </a:p>
              </p:txBody>
            </p:sp>
            <p:sp>
              <p:nvSpPr>
                <p:cNvPr id="9" name="CasellaDiTesto 8">
                  <a:extLst>
                    <a:ext uri="{FF2B5EF4-FFF2-40B4-BE49-F238E27FC236}">
                      <a16:creationId xmlns:a16="http://schemas.microsoft.com/office/drawing/2014/main" id="{EA4B918E-3EAB-434A-8B66-7F178831B3DB}"/>
                    </a:ext>
                  </a:extLst>
                </p:cNvPr>
                <p:cNvSpPr txBox="1"/>
                <p:nvPr/>
              </p:nvSpPr>
              <p:spPr>
                <a:xfrm>
                  <a:off x="5758478" y="5286858"/>
                  <a:ext cx="1082457" cy="3370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YSTOLE</a:t>
                  </a:r>
                </a:p>
              </p:txBody>
            </p:sp>
            <p:pic>
              <p:nvPicPr>
                <p:cNvPr id="10" name="Immagine 9">
                  <a:extLst>
                    <a:ext uri="{FF2B5EF4-FFF2-40B4-BE49-F238E27FC236}">
                      <a16:creationId xmlns:a16="http://schemas.microsoft.com/office/drawing/2014/main" id="{1A799F9C-7EE6-48B3-A862-D3A2770958F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101" t="28997" r="61373" b="38252"/>
                <a:stretch/>
              </p:blipFill>
              <p:spPr>
                <a:xfrm>
                  <a:off x="2903970" y="1241381"/>
                  <a:ext cx="2209217" cy="1971363"/>
                </a:xfrm>
                <a:prstGeom prst="rect">
                  <a:avLst/>
                </a:prstGeom>
                <a:ln>
                  <a:solidFill>
                    <a:schemeClr val="accent3">
                      <a:lumMod val="75000"/>
                    </a:schemeClr>
                  </a:solidFill>
                </a:ln>
              </p:spPr>
            </p:pic>
            <p:sp>
              <p:nvSpPr>
                <p:cNvPr id="11" name="CasellaDiTesto 10">
                  <a:extLst>
                    <a:ext uri="{FF2B5EF4-FFF2-40B4-BE49-F238E27FC236}">
                      <a16:creationId xmlns:a16="http://schemas.microsoft.com/office/drawing/2014/main" id="{7979AB74-A0FC-4140-8F72-201E6841D9AC}"/>
                    </a:ext>
                  </a:extLst>
                </p:cNvPr>
                <p:cNvSpPr txBox="1"/>
                <p:nvPr/>
              </p:nvSpPr>
              <p:spPr>
                <a:xfrm>
                  <a:off x="1652517" y="2069711"/>
                  <a:ext cx="1353421" cy="3370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BA/2J WT</a:t>
                  </a:r>
                </a:p>
              </p:txBody>
            </p:sp>
            <p:sp>
              <p:nvSpPr>
                <p:cNvPr id="12" name="CasellaDiTesto 11">
                  <a:extLst>
                    <a:ext uri="{FF2B5EF4-FFF2-40B4-BE49-F238E27FC236}">
                      <a16:creationId xmlns:a16="http://schemas.microsoft.com/office/drawing/2014/main" id="{F13FFFAE-487F-4787-A578-EB5C5FA94DF6}"/>
                    </a:ext>
                  </a:extLst>
                </p:cNvPr>
                <p:cNvSpPr txBox="1"/>
                <p:nvPr/>
              </p:nvSpPr>
              <p:spPr>
                <a:xfrm>
                  <a:off x="1808616" y="3950840"/>
                  <a:ext cx="104122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2-</a:t>
                  </a:r>
                  <a:r>
                    <a:rPr lang="it-IT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dx</a:t>
                  </a:r>
                </a:p>
              </p:txBody>
            </p:sp>
            <p:pic>
              <p:nvPicPr>
                <p:cNvPr id="13" name="Immagine 12">
                  <a:extLst>
                    <a:ext uri="{FF2B5EF4-FFF2-40B4-BE49-F238E27FC236}">
                      <a16:creationId xmlns:a16="http://schemas.microsoft.com/office/drawing/2014/main" id="{E0613AF1-27FF-4457-AF76-219C9B9E5A2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1197" t="27628" r="11036" b="39288"/>
                <a:stretch/>
              </p:blipFill>
              <p:spPr>
                <a:xfrm>
                  <a:off x="5180324" y="1252568"/>
                  <a:ext cx="2206067" cy="1971363"/>
                </a:xfrm>
                <a:prstGeom prst="rect">
                  <a:avLst/>
                </a:prstGeom>
                <a:ln>
                  <a:solidFill>
                    <a:schemeClr val="accent3">
                      <a:lumMod val="75000"/>
                    </a:schemeClr>
                  </a:solidFill>
                </a:ln>
              </p:spPr>
            </p:pic>
            <p:sp>
              <p:nvSpPr>
                <p:cNvPr id="3" name="CasellaDiTesto 2">
                  <a:extLst>
                    <a:ext uri="{FF2B5EF4-FFF2-40B4-BE49-F238E27FC236}">
                      <a16:creationId xmlns:a16="http://schemas.microsoft.com/office/drawing/2014/main" id="{CE5B168A-1ACE-4B4F-80EA-BC794DA4A7AB}"/>
                    </a:ext>
                  </a:extLst>
                </p:cNvPr>
                <p:cNvSpPr txBox="1"/>
                <p:nvPr/>
              </p:nvSpPr>
              <p:spPr>
                <a:xfrm>
                  <a:off x="3969025" y="2002042"/>
                  <a:ext cx="429163" cy="2757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200" b="1" dirty="0">
                      <a:solidFill>
                        <a:schemeClr val="bg1"/>
                      </a:solidFill>
                    </a:rPr>
                    <a:t>LV</a:t>
                  </a:r>
                </a:p>
              </p:txBody>
            </p:sp>
            <p:sp>
              <p:nvSpPr>
                <p:cNvPr id="14" name="CasellaDiTesto 13">
                  <a:extLst>
                    <a:ext uri="{FF2B5EF4-FFF2-40B4-BE49-F238E27FC236}">
                      <a16:creationId xmlns:a16="http://schemas.microsoft.com/office/drawing/2014/main" id="{AEA21A5F-CD69-4187-8FEB-AA71EBEAE9E8}"/>
                    </a:ext>
                  </a:extLst>
                </p:cNvPr>
                <p:cNvSpPr txBox="1"/>
                <p:nvPr/>
              </p:nvSpPr>
              <p:spPr>
                <a:xfrm>
                  <a:off x="4029778" y="1677800"/>
                  <a:ext cx="468351" cy="27579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200" b="1" dirty="0">
                      <a:solidFill>
                        <a:schemeClr val="bg1"/>
                      </a:solidFill>
                    </a:rPr>
                    <a:t>IVS</a:t>
                  </a:r>
                </a:p>
              </p:txBody>
            </p:sp>
            <p:cxnSp>
              <p:nvCxnSpPr>
                <p:cNvPr id="15" name="Connettore 2 14">
                  <a:extLst>
                    <a:ext uri="{FF2B5EF4-FFF2-40B4-BE49-F238E27FC236}">
                      <a16:creationId xmlns:a16="http://schemas.microsoft.com/office/drawing/2014/main" id="{80E6A94F-0FF3-4819-B7D8-A0523E0DB165}"/>
                    </a:ext>
                  </a:extLst>
                </p:cNvPr>
                <p:cNvCxnSpPr/>
                <p:nvPr/>
              </p:nvCxnSpPr>
              <p:spPr>
                <a:xfrm flipH="1">
                  <a:off x="3857600" y="3466935"/>
                  <a:ext cx="111306" cy="169277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Connettore 2 15">
                  <a:extLst>
                    <a:ext uri="{FF2B5EF4-FFF2-40B4-BE49-F238E27FC236}">
                      <a16:creationId xmlns:a16="http://schemas.microsoft.com/office/drawing/2014/main" id="{7F5191D3-7858-4A6D-A66E-B2D24A461CE5}"/>
                    </a:ext>
                  </a:extLst>
                </p:cNvPr>
                <p:cNvCxnSpPr/>
                <p:nvPr/>
              </p:nvCxnSpPr>
              <p:spPr>
                <a:xfrm flipH="1">
                  <a:off x="3042064" y="3680766"/>
                  <a:ext cx="111306" cy="169277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Connettore 2 16">
                  <a:extLst>
                    <a:ext uri="{FF2B5EF4-FFF2-40B4-BE49-F238E27FC236}">
                      <a16:creationId xmlns:a16="http://schemas.microsoft.com/office/drawing/2014/main" id="{127579C2-971E-46ED-BD1F-F5AACFF262D2}"/>
                    </a:ext>
                  </a:extLst>
                </p:cNvPr>
                <p:cNvCxnSpPr/>
                <p:nvPr/>
              </p:nvCxnSpPr>
              <p:spPr>
                <a:xfrm flipH="1">
                  <a:off x="4299964" y="3872130"/>
                  <a:ext cx="111306" cy="169277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Connettore 2 17">
                  <a:extLst>
                    <a:ext uri="{FF2B5EF4-FFF2-40B4-BE49-F238E27FC236}">
                      <a16:creationId xmlns:a16="http://schemas.microsoft.com/office/drawing/2014/main" id="{68D54C35-48C0-4499-ABED-CCF068A5EFA6}"/>
                    </a:ext>
                  </a:extLst>
                </p:cNvPr>
                <p:cNvCxnSpPr/>
                <p:nvPr/>
              </p:nvCxnSpPr>
              <p:spPr>
                <a:xfrm flipH="1">
                  <a:off x="3929837" y="4512031"/>
                  <a:ext cx="111306" cy="169277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Connettore 2 18">
                  <a:extLst>
                    <a:ext uri="{FF2B5EF4-FFF2-40B4-BE49-F238E27FC236}">
                      <a16:creationId xmlns:a16="http://schemas.microsoft.com/office/drawing/2014/main" id="{FCF9964B-C86D-43FF-B958-CFF99D6333F7}"/>
                    </a:ext>
                  </a:extLst>
                </p:cNvPr>
                <p:cNvCxnSpPr/>
                <p:nvPr/>
              </p:nvCxnSpPr>
              <p:spPr>
                <a:xfrm flipH="1">
                  <a:off x="4478486" y="4342755"/>
                  <a:ext cx="111306" cy="169277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470BB316-152B-4AA4-962F-E4773FBAD8E8}"/>
                  </a:ext>
                </a:extLst>
              </p:cNvPr>
              <p:cNvSpPr txBox="1"/>
              <p:nvPr/>
            </p:nvSpPr>
            <p:spPr>
              <a:xfrm>
                <a:off x="4963896" y="777508"/>
                <a:ext cx="46835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>
                    <a:solidFill>
                      <a:schemeClr val="bg1"/>
                    </a:solidFill>
                  </a:rPr>
                  <a:t>RV</a:t>
                </a:r>
              </a:p>
            </p:txBody>
          </p:sp>
        </p:grp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A46C65C9-2F01-4ADD-B61C-369660F33848}"/>
                </a:ext>
              </a:extLst>
            </p:cNvPr>
            <p:cNvSpPr txBox="1"/>
            <p:nvPr/>
          </p:nvSpPr>
          <p:spPr>
            <a:xfrm>
              <a:off x="6014102" y="921030"/>
              <a:ext cx="468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solidFill>
                    <a:schemeClr val="bg1"/>
                  </a:solidFill>
                </a:rPr>
                <a:t>RA</a:t>
              </a:r>
            </a:p>
          </p:txBody>
        </p: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01525F04-EEBD-427C-BE8A-B8853C4D7628}"/>
                </a:ext>
              </a:extLst>
            </p:cNvPr>
            <p:cNvSpPr txBox="1"/>
            <p:nvPr/>
          </p:nvSpPr>
          <p:spPr>
            <a:xfrm>
              <a:off x="6071043" y="1767232"/>
              <a:ext cx="46835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solidFill>
                    <a:schemeClr val="bg1"/>
                  </a:solidFill>
                </a:rPr>
                <a:t>LA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CC7B03AC-3CAE-44FA-A4EA-4F37C7BD14D7}"/>
                </a:ext>
              </a:extLst>
            </p:cNvPr>
            <p:cNvSpPr txBox="1"/>
            <p:nvPr/>
          </p:nvSpPr>
          <p:spPr>
            <a:xfrm>
              <a:off x="5654304" y="1579261"/>
              <a:ext cx="5040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solidFill>
                    <a:schemeClr val="bg1"/>
                  </a:solidFill>
                </a:rPr>
                <a:t>MVL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3BBAD6C8-5DDF-445F-AE0E-5014D03FA8AA}"/>
                </a:ext>
              </a:extLst>
            </p:cNvPr>
            <p:cNvSpPr txBox="1"/>
            <p:nvPr/>
          </p:nvSpPr>
          <p:spPr>
            <a:xfrm>
              <a:off x="5145761" y="1669693"/>
              <a:ext cx="5403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solidFill>
                    <a:schemeClr val="bg1"/>
                  </a:solidFill>
                </a:rPr>
                <a:t>MSA</a:t>
              </a:r>
            </a:p>
          </p:txBody>
        </p:sp>
      </p:grp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32A31F34-2D5C-99B2-4237-3C2C0F6B12A4}"/>
              </a:ext>
            </a:extLst>
          </p:cNvPr>
          <p:cNvSpPr txBox="1"/>
          <p:nvPr/>
        </p:nvSpPr>
        <p:spPr>
          <a:xfrm>
            <a:off x="1178871" y="5198306"/>
            <a:ext cx="10138811" cy="13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8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dimensional echocardiography in 16-17 weeks old DBA/2J WT and D2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dx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rasternal longitudinal-axis view. Right ventricle (RV); interventricular septum (IVS); left ventricle (LV); right atrium (RA); left atrium (LA); mitral valve leaflet (MVL); mitral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bvalvular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pparatus (MSA). Arrows indicate increased cardiac hyper-echogenic areas. 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3261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FF4195B8-1646-D1BA-8B70-6905511052F5}"/>
              </a:ext>
            </a:extLst>
          </p:cNvPr>
          <p:cNvSpPr txBox="1"/>
          <p:nvPr/>
        </p:nvSpPr>
        <p:spPr>
          <a:xfrm>
            <a:off x="1178871" y="4865799"/>
            <a:ext cx="10138811" cy="1664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volution of left ventricular end diastolic volume/body weight and left ventricular end systolic volume/body weight in mice from 16-17 to 24-25 weeks of ag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Data ar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±SEM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n = 10 for each group. Left ventricular end diastolic volume/body weight (LVEDV/BW); left ventricular end systolic volume/body weight (LVESV/BW). Two-way ANOVA mixed-effects model A) LVEDV/BW; B) LVESV/BW.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Immagine 8" descr="Immagine che contiene diagramma, testo, linea, Disegno tecnico&#10;&#10;Descrizione generata automaticamente">
            <a:extLst>
              <a:ext uri="{FF2B5EF4-FFF2-40B4-BE49-F238E27FC236}">
                <a16:creationId xmlns:a16="http://schemas.microsoft.com/office/drawing/2014/main" id="{A9FB35B2-070A-05FE-1D65-1B65BF22D1A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2036" y="583632"/>
            <a:ext cx="8522624" cy="42821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38918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48D657A0-C216-B2D7-435F-F5D563F81BE2}"/>
              </a:ext>
            </a:extLst>
          </p:cNvPr>
          <p:cNvSpPr txBox="1"/>
          <p:nvPr/>
        </p:nvSpPr>
        <p:spPr>
          <a:xfrm>
            <a:off x="1178871" y="4828855"/>
            <a:ext cx="10138811" cy="13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volution of right ventricular cardiac output and stroke volume in mice from 16-17 to 24-25 weeks of ag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Data ar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±SEM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n = 10 for each group. Right ventricular cardiac output (CO_RV); right ventricle stroke volume (SV_RV).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wo-way ANOVA: p&lt;0.0001 for CO_RV (A), p&lt;0.001 for SV_RV (B)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Šídák'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ltiple comparisons post-hoc test; **p&lt;0.01, ***p&lt;0.001, ****p&lt;0.0001 vs DBA/2J WT.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Immagine 6" descr="Immagine che contiene diagramma, testo, linea&#10;&#10;Descrizione generata automaticamente">
            <a:extLst>
              <a:ext uri="{FF2B5EF4-FFF2-40B4-BE49-F238E27FC236}">
                <a16:creationId xmlns:a16="http://schemas.microsoft.com/office/drawing/2014/main" id="{2642B446-4861-F609-6E17-0B39C6DD1E0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7260" y="1188104"/>
            <a:ext cx="9079992" cy="3462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97522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 descr="Immagine che contiene testo, diagramma, schermata, design&#10;&#10;Descrizione generata automaticamente">
            <a:extLst>
              <a:ext uri="{FF2B5EF4-FFF2-40B4-BE49-F238E27FC236}">
                <a16:creationId xmlns:a16="http://schemas.microsoft.com/office/drawing/2014/main" id="{A6AD4FDF-062A-526B-5BCC-3930846636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223" y="497671"/>
            <a:ext cx="9714900" cy="6124807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557CAF6E-D1B2-E069-869A-F517528AB81D}"/>
              </a:ext>
            </a:extLst>
          </p:cNvPr>
          <p:cNvSpPr txBox="1"/>
          <p:nvPr/>
        </p:nvSpPr>
        <p:spPr>
          <a:xfrm>
            <a:off x="7557307" y="317557"/>
            <a:ext cx="4187209" cy="3755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Cardiac leukocyte infiltration, CD45 immunostaining in right ventricle, left ventricle and interventricular septum in 24-25 weeks old mice.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orizontal lines represent mean values for CD45+ cells. The dashed line indicates a threshold of normality; n = 10 for each group. Left ventricle (LV); intraventricular septum (IVS); right ventricle (RV). A) Representative macro and micro photographs of anti-CD45 antibody staining (20X) in 24-25 weeks old D2-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dx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. Red arrows indicate CD45+ cells; B)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) and D) CD45+ cells/mm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V, LV and IVS, respectively. </a:t>
            </a:r>
            <a:endParaRPr lang="it-IT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01492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669471DF-04A1-88D1-3ACF-94B2A08FF858}"/>
              </a:ext>
            </a:extLst>
          </p:cNvPr>
          <p:cNvSpPr txBox="1"/>
          <p:nvPr/>
        </p:nvSpPr>
        <p:spPr>
          <a:xfrm>
            <a:off x="1178871" y="4865799"/>
            <a:ext cx="10138811" cy="13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Correlation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tween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diac functional and histological parameters in 16-17 and 24-25 weeks old D2-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dx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ft ventricular ejection fraction (LVEF); left ventricle (LV); right ventricle (RV); pulmonary artery acceleration time (PAAT). A) LVEF and LV interstitial fibrosis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4-25 weeks old mice, ρ=-0.68, p=0.03; B) PAAT and RV total fibrosis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6-17 weeks old mice, ρ=-0.81, p=0.005.</a:t>
            </a:r>
            <a:endParaRPr lang="it-IT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1" name="Immagine 10" descr="Immagine che contiene testo, diagramma, linea, Carattere&#10;&#10;Descrizione generata automaticamente">
            <a:extLst>
              <a:ext uri="{FF2B5EF4-FFF2-40B4-BE49-F238E27FC236}">
                <a16:creationId xmlns:a16="http://schemas.microsoft.com/office/drawing/2014/main" id="{FB61F78D-ADE7-10ED-5A29-EFD8202CFD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4233" y="1246909"/>
            <a:ext cx="8819521" cy="30726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64513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68F1021F-205E-6E23-A450-E59871435924}"/>
              </a:ext>
            </a:extLst>
          </p:cNvPr>
          <p:cNvGraphicFramePr>
            <a:graphicFrameLocks noGrp="1"/>
          </p:cNvGraphicFramePr>
          <p:nvPr/>
        </p:nvGraphicFramePr>
        <p:xfrm>
          <a:off x="6308437" y="680029"/>
          <a:ext cx="5065690" cy="549794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10687">
                  <a:extLst>
                    <a:ext uri="{9D8B030D-6E8A-4147-A177-3AD203B41FA5}">
                      <a16:colId xmlns:a16="http://schemas.microsoft.com/office/drawing/2014/main" val="1404101789"/>
                    </a:ext>
                  </a:extLst>
                </a:gridCol>
                <a:gridCol w="723305">
                  <a:extLst>
                    <a:ext uri="{9D8B030D-6E8A-4147-A177-3AD203B41FA5}">
                      <a16:colId xmlns:a16="http://schemas.microsoft.com/office/drawing/2014/main" val="2876416252"/>
                    </a:ext>
                  </a:extLst>
                </a:gridCol>
                <a:gridCol w="723816">
                  <a:extLst>
                    <a:ext uri="{9D8B030D-6E8A-4147-A177-3AD203B41FA5}">
                      <a16:colId xmlns:a16="http://schemas.microsoft.com/office/drawing/2014/main" val="1788199027"/>
                    </a:ext>
                  </a:extLst>
                </a:gridCol>
                <a:gridCol w="651333">
                  <a:extLst>
                    <a:ext uri="{9D8B030D-6E8A-4147-A177-3AD203B41FA5}">
                      <a16:colId xmlns:a16="http://schemas.microsoft.com/office/drawing/2014/main" val="1891331464"/>
                    </a:ext>
                  </a:extLst>
                </a:gridCol>
                <a:gridCol w="650822">
                  <a:extLst>
                    <a:ext uri="{9D8B030D-6E8A-4147-A177-3AD203B41FA5}">
                      <a16:colId xmlns:a16="http://schemas.microsoft.com/office/drawing/2014/main" val="1145483818"/>
                    </a:ext>
                  </a:extLst>
                </a:gridCol>
                <a:gridCol w="723816">
                  <a:extLst>
                    <a:ext uri="{9D8B030D-6E8A-4147-A177-3AD203B41FA5}">
                      <a16:colId xmlns:a16="http://schemas.microsoft.com/office/drawing/2014/main" val="1752963896"/>
                    </a:ext>
                  </a:extLst>
                </a:gridCol>
                <a:gridCol w="581911">
                  <a:extLst>
                    <a:ext uri="{9D8B030D-6E8A-4147-A177-3AD203B41FA5}">
                      <a16:colId xmlns:a16="http://schemas.microsoft.com/office/drawing/2014/main" val="1599750835"/>
                    </a:ext>
                  </a:extLst>
                </a:gridCol>
              </a:tblGrid>
              <a:tr h="515217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500">
                        <a:effectLst/>
                      </a:endParaRP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 dirty="0">
                          <a:effectLst/>
                        </a:rPr>
                        <a:t>DBA/2J WT</a:t>
                      </a:r>
                      <a:endParaRPr lang="it-IT" sz="500" dirty="0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 dirty="0">
                          <a:effectLst/>
                        </a:rPr>
                        <a:t>n=10</a:t>
                      </a:r>
                      <a:endParaRPr lang="it-IT" sz="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D2-mdx</a:t>
                      </a:r>
                      <a:endParaRPr lang="it-IT" sz="500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n=1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5761095"/>
                  </a:ext>
                </a:extLst>
              </a:tr>
              <a:tr h="39672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 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6-17 weeks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0-21 weeks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4-25 weeks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6-17 weeks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0-21 weeks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4-25 weeks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3988665211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BW, g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9.7±0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0.9±0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0.7±0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3.8±0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4.7±0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3.7±0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1201892987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HR, bp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41.6±12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42.8±24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89.9±8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70.3±7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38.1±16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86±8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2026776094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Ao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2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0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2±0.0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2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2925785367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A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4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4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4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2042521794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AWth_d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2110008538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AWth_s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9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7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.0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6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6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6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971929242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DD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.0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.9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 dirty="0">
                          <a:effectLst/>
                        </a:rPr>
                        <a:t>3.1±0.0</a:t>
                      </a:r>
                      <a:endParaRPr lang="it-IT" sz="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 dirty="0">
                          <a:effectLst/>
                        </a:rPr>
                        <a:t>2.7±0.0</a:t>
                      </a:r>
                      <a:endParaRPr lang="it-IT" sz="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.8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.9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749254142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SD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0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1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1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4184784734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Wth_d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8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2410444958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Wth_s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8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6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8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6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5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5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2380851754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SF, %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71.2±1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4.7±1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9.3±1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7.6±1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0.4±3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1.6±3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393162736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DV, µL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2.2±2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2.0±3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4.8±2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9.6±1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7.7±1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6±2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4291471827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SV, µL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.7±0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.6±0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.1±0.8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.6±1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.7±0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7.3±0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3927699988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F, %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7.9±0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9.4±0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92±1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0.2±2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7.2±0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76.8±2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4246322226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E vel, cm/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03.7±3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97.5±3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09.5±3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71.1±2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6.9±4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78.3±3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2977424803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A vel, cm/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4.5±2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3.1±4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98.8±3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8.3±2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0.6±3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72.4±2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603204648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E/A, ratio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2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1±0.0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2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1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1±0.0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364823790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DT, m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0.7±0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2.2±0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2.9±1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2.0±0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6.6±1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3±0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3554131519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CO, µL/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5.6±1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0.0±2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9.2±2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4±1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2.2±1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3.1±1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2627311366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SV, µL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3.0±2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7.0±3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6.8±2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1.6±2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1.1±3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9.4±1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189001416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AAT, m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5.6±1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3.4±0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4.0±0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1.6±0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1.7±0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0.2±0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3885849612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ET, m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3.6±1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7.2±1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8.7±0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 dirty="0">
                          <a:effectLst/>
                        </a:rPr>
                        <a:t>51.7±1.9</a:t>
                      </a:r>
                      <a:endParaRPr lang="it-IT" sz="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8.2±1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5.1±1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3071948940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AAT/ET, ratio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3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3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3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2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2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2±0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1252889128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CO_RV, µL/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2.0±1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25.7±1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36.2±3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23.8±2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15.7±1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18.3±1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826697278"/>
                  </a:ext>
                </a:extLst>
              </a:tr>
              <a:tr h="1834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SV_RV, µL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50.5±2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38.7±1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51.7±3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41.4±3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28.7±2.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 dirty="0">
                          <a:effectLst/>
                        </a:rPr>
                        <a:t>28.6±2.7</a:t>
                      </a:r>
                      <a:endParaRPr lang="it-IT" sz="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2084" marR="32084" marT="0" marB="0"/>
                </a:tc>
                <a:extLst>
                  <a:ext uri="{0D108BD9-81ED-4DB2-BD59-A6C34878D82A}">
                    <a16:rowId xmlns:a16="http://schemas.microsoft.com/office/drawing/2014/main" val="3734476005"/>
                  </a:ext>
                </a:extLst>
              </a:tr>
            </a:tbl>
          </a:graphicData>
        </a:graphic>
      </p:graphicFrame>
      <p:sp>
        <p:nvSpPr>
          <p:cNvPr id="4" name="CasellaDiTesto 3">
            <a:extLst>
              <a:ext uri="{FF2B5EF4-FFF2-40B4-BE49-F238E27FC236}">
                <a16:creationId xmlns:a16="http://schemas.microsoft.com/office/drawing/2014/main" id="{9BE9D1BC-5572-9332-9F08-50430FC3EAF6}"/>
              </a:ext>
            </a:extLst>
          </p:cNvPr>
          <p:cNvSpPr txBox="1"/>
          <p:nvPr/>
        </p:nvSpPr>
        <p:spPr>
          <a:xfrm>
            <a:off x="360218" y="680029"/>
            <a:ext cx="5181600" cy="3785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hocardiographic variables in DBA/2J WT and D2-mdx mice at 16-17, 20-21 and 24-25 weeks of age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ta are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W: body weight; HR: heart rate; LA: left atrial diameter;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o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ortic diameter;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WTh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nterior wall thickness;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VEDd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left ventricular end diastolic diameter; LVEDs: left ventricular end systolic diameter;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WTh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osterior wall diastolic thickness. SF: shortening fraction; LVEDV: left ventricular end diastolic volume, LVESV: left ventricular end systolic volume, LVEF: left ventricular ejection fraction, E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l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eak E wave velocity; A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l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eak A wave velocity; DT: deceleration time; CO: left ventricular cardiac output; SV: left ventricular stroke volume; PAAT: pulmonary arterial acceleration time, ET, pulmonary ejection time; CO_RV, right ventricular cardiac output; SV_RV, right ventricular stroke volume.</a:t>
            </a:r>
          </a:p>
        </p:txBody>
      </p:sp>
    </p:spTree>
    <p:extLst>
      <p:ext uri="{BB962C8B-B14F-4D97-AF65-F5344CB8AC3E}">
        <p14:creationId xmlns:p14="http://schemas.microsoft.com/office/powerpoint/2010/main" val="15830450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9BE9D1BC-5572-9332-9F08-50430FC3EAF6}"/>
              </a:ext>
            </a:extLst>
          </p:cNvPr>
          <p:cNvSpPr txBox="1"/>
          <p:nvPr/>
        </p:nvSpPr>
        <p:spPr>
          <a:xfrm>
            <a:off x="360218" y="680029"/>
            <a:ext cx="5181600" cy="43216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.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chocardiographic variables in 16-17 weeks old DBA/2J WT and D2-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dx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.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ata are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±SEM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BW: bodyweight; HR: heart rate; LA: left atrial diameter;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o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aortic diameter;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WTh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anterior wall thickness;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VEDd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left ventricular end diastolic diameter; LVEDs: left ventricular end systolic diameter;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WTh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posterior wall diastolic thickness. SF: shortening fraction; LVEDV: left ventricular end diastolic volume, LVESV: left ventricular end systolic volume, LVEF: left ventricular ejection fraction, E vel: peak E wave velocity; A vel: peak A wave velocity; DT: deceleration time; CO: left ventricular cardiac output; SV: left ventricular stroke volume; PAAT: pulmonary arterial acceleration time, ET, pulmonary ejection time; CO_RV, right ventricular cardiac output; SV_RV, right ventricular stroke volume.</a:t>
            </a:r>
            <a:endParaRPr lang="it-IT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id="{DA8064FC-2F10-5467-1742-833AB0F53639}"/>
              </a:ext>
            </a:extLst>
          </p:cNvPr>
          <p:cNvGraphicFramePr>
            <a:graphicFrameLocks noGrp="1"/>
          </p:cNvGraphicFramePr>
          <p:nvPr/>
        </p:nvGraphicFramePr>
        <p:xfrm>
          <a:off x="6377363" y="332509"/>
          <a:ext cx="4780164" cy="566589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52517">
                  <a:extLst>
                    <a:ext uri="{9D8B030D-6E8A-4147-A177-3AD203B41FA5}">
                      <a16:colId xmlns:a16="http://schemas.microsoft.com/office/drawing/2014/main" val="48344382"/>
                    </a:ext>
                  </a:extLst>
                </a:gridCol>
                <a:gridCol w="1326365">
                  <a:extLst>
                    <a:ext uri="{9D8B030D-6E8A-4147-A177-3AD203B41FA5}">
                      <a16:colId xmlns:a16="http://schemas.microsoft.com/office/drawing/2014/main" val="3509282370"/>
                    </a:ext>
                  </a:extLst>
                </a:gridCol>
                <a:gridCol w="1241317">
                  <a:extLst>
                    <a:ext uri="{9D8B030D-6E8A-4147-A177-3AD203B41FA5}">
                      <a16:colId xmlns:a16="http://schemas.microsoft.com/office/drawing/2014/main" val="28771541"/>
                    </a:ext>
                  </a:extLst>
                </a:gridCol>
                <a:gridCol w="1059965">
                  <a:extLst>
                    <a:ext uri="{9D8B030D-6E8A-4147-A177-3AD203B41FA5}">
                      <a16:colId xmlns:a16="http://schemas.microsoft.com/office/drawing/2014/main" val="1935819513"/>
                    </a:ext>
                  </a:extLst>
                </a:gridCol>
              </a:tblGrid>
              <a:tr h="7766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DBA/2J WT</a:t>
                      </a:r>
                      <a:endParaRPr lang="it-IT" sz="500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16-17 weeks old (n=20)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D2-mdx </a:t>
                      </a:r>
                      <a:endParaRPr lang="it-IT" sz="500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16-17 weeks old (n=20)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p value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486843229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BW, g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29.7±0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23.8±0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&lt;0.00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17155874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HR, bp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600">
                          <a:effectLst/>
                        </a:rPr>
                        <a:t>641.6±12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70.3±7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&lt;0.00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1460066875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Ao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0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4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2590543444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A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4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4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0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641962559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AWth_d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4227547503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AWth_s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9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6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&lt;0.00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3429314067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DD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.0±0.0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.7±0.0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0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1597359910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SD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2729486714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Wth_d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9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571199388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Wth_s, mm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8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6±0.0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0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906420945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SF, %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71.2±1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7.6±1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1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2594124238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DV, µL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2.2±2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9.6±1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0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29967047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SV, µL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.7±0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6.6±0.9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4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1531302838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LVEF, %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7.9±0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0.2±2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3059510345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E vel, cm/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03.7±3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71.1±2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&lt;0.00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2372415665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A vel, cm/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84.5±2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8.3±1.9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&lt;0.00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546837024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E/A, ratio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3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.2±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5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3993345928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DT, m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0.7±0.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2.0±0.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1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2932440765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CO, µL/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5.6±1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4.0±1.6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&lt;0.00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3359322893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SV, µL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3.0±2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1.6±2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2038025175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CO_RV, µL/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32.0±1.5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23.8±2.3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755687349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SV_RV, µL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0.5±2.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41.4±3.8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4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1135928394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AAT, m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5.6±0.9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11.6±0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0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986511181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ET, msec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3.6±1.1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51.7±1.9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37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4104645311"/>
                  </a:ext>
                </a:extLst>
              </a:tr>
              <a:tr h="19556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PAAT/ET, ratio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3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>
                          <a:effectLst/>
                        </a:rPr>
                        <a:t>0.2±0.02</a:t>
                      </a:r>
                      <a:endParaRPr lang="it-IT" sz="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it-IT" sz="600" dirty="0">
                          <a:effectLst/>
                        </a:rPr>
                        <a:t>0.01</a:t>
                      </a:r>
                      <a:endParaRPr lang="it-IT" sz="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3204" marR="33204" marT="0" marB="0"/>
                </a:tc>
                <a:extLst>
                  <a:ext uri="{0D108BD9-81ED-4DB2-BD59-A6C34878D82A}">
                    <a16:rowId xmlns:a16="http://schemas.microsoft.com/office/drawing/2014/main" val="5144737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185242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0</TotalTime>
  <Words>1296</Words>
  <Application>Microsoft Office PowerPoint</Application>
  <PresentationFormat>Widescreen</PresentationFormat>
  <Paragraphs>318</Paragraphs>
  <Slides>7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aria De Giorgio</dc:creator>
  <cp:lastModifiedBy>MDPI</cp:lastModifiedBy>
  <cp:revision>139</cp:revision>
  <cp:lastPrinted>2023-06-07T15:01:04Z</cp:lastPrinted>
  <dcterms:created xsi:type="dcterms:W3CDTF">2023-04-19T12:20:49Z</dcterms:created>
  <dcterms:modified xsi:type="dcterms:W3CDTF">2023-07-20T03:15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LPManualFileClassification">
    <vt:lpwstr>{1A067545-A4E2-4FA1-8094-0D7902669705}</vt:lpwstr>
  </property>
  <property fmtid="{D5CDD505-2E9C-101B-9397-08002B2CF9AE}" pid="3" name="DLPManualFileClassificationLastModifiedBy">
    <vt:lpwstr>italfarmaco\DR-LICANDRO</vt:lpwstr>
  </property>
  <property fmtid="{D5CDD505-2E9C-101B-9397-08002B2CF9AE}" pid="4" name="DLPManualFileClassificationLastModificationDate">
    <vt:lpwstr>1686304523</vt:lpwstr>
  </property>
  <property fmtid="{D5CDD505-2E9C-101B-9397-08002B2CF9AE}" pid="5" name="DLPManualFileClassificationVersion">
    <vt:lpwstr>11.10.0.29</vt:lpwstr>
  </property>
</Properties>
</file>